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60" r:id="rId3"/>
    <p:sldId id="265" r:id="rId4"/>
    <p:sldId id="257" r:id="rId5"/>
  </p:sldIdLst>
  <p:sldSz cx="723582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7" userDrawn="1">
          <p15:clr>
            <a:srgbClr val="A4A3A4"/>
          </p15:clr>
        </p15:guide>
        <p15:guide id="2" pos="22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8" d="100"/>
          <a:sy n="48" d="100"/>
        </p:scale>
        <p:origin x="2669" y="62"/>
      </p:cViewPr>
      <p:guideLst>
        <p:guide orient="horz" pos="3367"/>
        <p:guide pos="22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2687" y="1749795"/>
            <a:ext cx="6150451" cy="3722335"/>
          </a:xfrm>
        </p:spPr>
        <p:txBody>
          <a:bodyPr anchor="b"/>
          <a:lstStyle>
            <a:lvl1pPr algn="ctr">
              <a:defRPr sz="474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04478" y="5615678"/>
            <a:ext cx="5426869" cy="2581379"/>
          </a:xfrm>
        </p:spPr>
        <p:txBody>
          <a:bodyPr/>
          <a:lstStyle>
            <a:lvl1pPr marL="0" indent="0" algn="ctr">
              <a:buNone/>
              <a:defRPr sz="1899"/>
            </a:lvl1pPr>
            <a:lvl2pPr marL="361782" indent="0" algn="ctr">
              <a:buNone/>
              <a:defRPr sz="1583"/>
            </a:lvl2pPr>
            <a:lvl3pPr marL="723565" indent="0" algn="ctr">
              <a:buNone/>
              <a:defRPr sz="1424"/>
            </a:lvl3pPr>
            <a:lvl4pPr marL="1085347" indent="0" algn="ctr">
              <a:buNone/>
              <a:defRPr sz="1266"/>
            </a:lvl4pPr>
            <a:lvl5pPr marL="1447129" indent="0" algn="ctr">
              <a:buNone/>
              <a:defRPr sz="1266"/>
            </a:lvl5pPr>
            <a:lvl6pPr marL="1808912" indent="0" algn="ctr">
              <a:buNone/>
              <a:defRPr sz="1266"/>
            </a:lvl6pPr>
            <a:lvl7pPr marL="2170694" indent="0" algn="ctr">
              <a:buNone/>
              <a:defRPr sz="1266"/>
            </a:lvl7pPr>
            <a:lvl8pPr marL="2532477" indent="0" algn="ctr">
              <a:buNone/>
              <a:defRPr sz="1266"/>
            </a:lvl8pPr>
            <a:lvl9pPr marL="2894259" indent="0" algn="ctr">
              <a:buNone/>
              <a:defRPr sz="1266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3488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7555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78138" y="569240"/>
            <a:ext cx="156022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7464" y="569240"/>
            <a:ext cx="4590226" cy="90608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2760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587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3695" y="2665532"/>
            <a:ext cx="6240899" cy="4447496"/>
          </a:xfrm>
        </p:spPr>
        <p:txBody>
          <a:bodyPr anchor="b"/>
          <a:lstStyle>
            <a:lvl1pPr>
              <a:defRPr sz="474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3695" y="7155103"/>
            <a:ext cx="6240899" cy="2338833"/>
          </a:xfrm>
        </p:spPr>
        <p:txBody>
          <a:bodyPr/>
          <a:lstStyle>
            <a:lvl1pPr marL="0" indent="0">
              <a:buNone/>
              <a:defRPr sz="1899">
                <a:solidFill>
                  <a:schemeClr val="tx1"/>
                </a:solidFill>
              </a:defRPr>
            </a:lvl1pPr>
            <a:lvl2pPr marL="361782" indent="0">
              <a:buNone/>
              <a:defRPr sz="1583">
                <a:solidFill>
                  <a:schemeClr val="tx1">
                    <a:tint val="75000"/>
                  </a:schemeClr>
                </a:solidFill>
              </a:defRPr>
            </a:lvl2pPr>
            <a:lvl3pPr marL="723565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3pPr>
            <a:lvl4pPr marL="1085347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4pPr>
            <a:lvl5pPr marL="1447129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5pPr>
            <a:lvl6pPr marL="1808912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6pPr>
            <a:lvl7pPr marL="2170694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7pPr>
            <a:lvl8pPr marL="2532477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8pPr>
            <a:lvl9pPr marL="2894259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5535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7463" y="2846200"/>
            <a:ext cx="3075226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63136" y="2846200"/>
            <a:ext cx="3075226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529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5" y="569242"/>
            <a:ext cx="6240899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8406" y="2620980"/>
            <a:ext cx="3061093" cy="1284502"/>
          </a:xfrm>
        </p:spPr>
        <p:txBody>
          <a:bodyPr anchor="b"/>
          <a:lstStyle>
            <a:lvl1pPr marL="0" indent="0">
              <a:buNone/>
              <a:defRPr sz="1899" b="1"/>
            </a:lvl1pPr>
            <a:lvl2pPr marL="361782" indent="0">
              <a:buNone/>
              <a:defRPr sz="1583" b="1"/>
            </a:lvl2pPr>
            <a:lvl3pPr marL="723565" indent="0">
              <a:buNone/>
              <a:defRPr sz="1424" b="1"/>
            </a:lvl3pPr>
            <a:lvl4pPr marL="1085347" indent="0">
              <a:buNone/>
              <a:defRPr sz="1266" b="1"/>
            </a:lvl4pPr>
            <a:lvl5pPr marL="1447129" indent="0">
              <a:buNone/>
              <a:defRPr sz="1266" b="1"/>
            </a:lvl5pPr>
            <a:lvl6pPr marL="1808912" indent="0">
              <a:buNone/>
              <a:defRPr sz="1266" b="1"/>
            </a:lvl6pPr>
            <a:lvl7pPr marL="2170694" indent="0">
              <a:buNone/>
              <a:defRPr sz="1266" b="1"/>
            </a:lvl7pPr>
            <a:lvl8pPr marL="2532477" indent="0">
              <a:buNone/>
              <a:defRPr sz="1266" b="1"/>
            </a:lvl8pPr>
            <a:lvl9pPr marL="2894259" indent="0">
              <a:buNone/>
              <a:defRPr sz="126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8406" y="3905482"/>
            <a:ext cx="3061093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63137" y="2620980"/>
            <a:ext cx="3076168" cy="1284502"/>
          </a:xfrm>
        </p:spPr>
        <p:txBody>
          <a:bodyPr anchor="b"/>
          <a:lstStyle>
            <a:lvl1pPr marL="0" indent="0">
              <a:buNone/>
              <a:defRPr sz="1899" b="1"/>
            </a:lvl1pPr>
            <a:lvl2pPr marL="361782" indent="0">
              <a:buNone/>
              <a:defRPr sz="1583" b="1"/>
            </a:lvl2pPr>
            <a:lvl3pPr marL="723565" indent="0">
              <a:buNone/>
              <a:defRPr sz="1424" b="1"/>
            </a:lvl3pPr>
            <a:lvl4pPr marL="1085347" indent="0">
              <a:buNone/>
              <a:defRPr sz="1266" b="1"/>
            </a:lvl4pPr>
            <a:lvl5pPr marL="1447129" indent="0">
              <a:buNone/>
              <a:defRPr sz="1266" b="1"/>
            </a:lvl5pPr>
            <a:lvl6pPr marL="1808912" indent="0">
              <a:buNone/>
              <a:defRPr sz="1266" b="1"/>
            </a:lvl6pPr>
            <a:lvl7pPr marL="2170694" indent="0">
              <a:buNone/>
              <a:defRPr sz="1266" b="1"/>
            </a:lvl7pPr>
            <a:lvl8pPr marL="2532477" indent="0">
              <a:buNone/>
              <a:defRPr sz="1266" b="1"/>
            </a:lvl8pPr>
            <a:lvl9pPr marL="2894259" indent="0">
              <a:buNone/>
              <a:defRPr sz="126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63137" y="3905482"/>
            <a:ext cx="3076168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8746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27099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913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5" y="712788"/>
            <a:ext cx="2333742" cy="2494756"/>
          </a:xfrm>
        </p:spPr>
        <p:txBody>
          <a:bodyPr anchor="b"/>
          <a:lstStyle>
            <a:lvl1pPr>
              <a:defRPr sz="253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76168" y="1539425"/>
            <a:ext cx="3663136" cy="7598117"/>
          </a:xfrm>
        </p:spPr>
        <p:txBody>
          <a:bodyPr/>
          <a:lstStyle>
            <a:lvl1pPr>
              <a:defRPr sz="2532"/>
            </a:lvl1pPr>
            <a:lvl2pPr>
              <a:defRPr sz="2216"/>
            </a:lvl2pPr>
            <a:lvl3pPr>
              <a:defRPr sz="1899"/>
            </a:lvl3pPr>
            <a:lvl4pPr>
              <a:defRPr sz="1583"/>
            </a:lvl4pPr>
            <a:lvl5pPr>
              <a:defRPr sz="1583"/>
            </a:lvl5pPr>
            <a:lvl6pPr>
              <a:defRPr sz="1583"/>
            </a:lvl6pPr>
            <a:lvl7pPr>
              <a:defRPr sz="1583"/>
            </a:lvl7pPr>
            <a:lvl8pPr>
              <a:defRPr sz="1583"/>
            </a:lvl8pPr>
            <a:lvl9pPr>
              <a:defRPr sz="158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8405" y="3207544"/>
            <a:ext cx="2333742" cy="5942372"/>
          </a:xfrm>
        </p:spPr>
        <p:txBody>
          <a:bodyPr/>
          <a:lstStyle>
            <a:lvl1pPr marL="0" indent="0">
              <a:buNone/>
              <a:defRPr sz="1266"/>
            </a:lvl1pPr>
            <a:lvl2pPr marL="361782" indent="0">
              <a:buNone/>
              <a:defRPr sz="1108"/>
            </a:lvl2pPr>
            <a:lvl3pPr marL="723565" indent="0">
              <a:buNone/>
              <a:defRPr sz="950"/>
            </a:lvl3pPr>
            <a:lvl4pPr marL="1085347" indent="0">
              <a:buNone/>
              <a:defRPr sz="791"/>
            </a:lvl4pPr>
            <a:lvl5pPr marL="1447129" indent="0">
              <a:buNone/>
              <a:defRPr sz="791"/>
            </a:lvl5pPr>
            <a:lvl6pPr marL="1808912" indent="0">
              <a:buNone/>
              <a:defRPr sz="791"/>
            </a:lvl6pPr>
            <a:lvl7pPr marL="2170694" indent="0">
              <a:buNone/>
              <a:defRPr sz="791"/>
            </a:lvl7pPr>
            <a:lvl8pPr marL="2532477" indent="0">
              <a:buNone/>
              <a:defRPr sz="791"/>
            </a:lvl8pPr>
            <a:lvl9pPr marL="2894259" indent="0">
              <a:buNone/>
              <a:defRPr sz="79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3738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5" y="712788"/>
            <a:ext cx="2333742" cy="2494756"/>
          </a:xfrm>
        </p:spPr>
        <p:txBody>
          <a:bodyPr anchor="b"/>
          <a:lstStyle>
            <a:lvl1pPr>
              <a:defRPr sz="253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76168" y="1539425"/>
            <a:ext cx="3663136" cy="7598117"/>
          </a:xfrm>
        </p:spPr>
        <p:txBody>
          <a:bodyPr anchor="t"/>
          <a:lstStyle>
            <a:lvl1pPr marL="0" indent="0">
              <a:buNone/>
              <a:defRPr sz="2532"/>
            </a:lvl1pPr>
            <a:lvl2pPr marL="361782" indent="0">
              <a:buNone/>
              <a:defRPr sz="2216"/>
            </a:lvl2pPr>
            <a:lvl3pPr marL="723565" indent="0">
              <a:buNone/>
              <a:defRPr sz="1899"/>
            </a:lvl3pPr>
            <a:lvl4pPr marL="1085347" indent="0">
              <a:buNone/>
              <a:defRPr sz="1583"/>
            </a:lvl4pPr>
            <a:lvl5pPr marL="1447129" indent="0">
              <a:buNone/>
              <a:defRPr sz="1583"/>
            </a:lvl5pPr>
            <a:lvl6pPr marL="1808912" indent="0">
              <a:buNone/>
              <a:defRPr sz="1583"/>
            </a:lvl6pPr>
            <a:lvl7pPr marL="2170694" indent="0">
              <a:buNone/>
              <a:defRPr sz="1583"/>
            </a:lvl7pPr>
            <a:lvl8pPr marL="2532477" indent="0">
              <a:buNone/>
              <a:defRPr sz="1583"/>
            </a:lvl8pPr>
            <a:lvl9pPr marL="2894259" indent="0">
              <a:buNone/>
              <a:defRPr sz="1583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8405" y="3207544"/>
            <a:ext cx="2333742" cy="5942372"/>
          </a:xfrm>
        </p:spPr>
        <p:txBody>
          <a:bodyPr/>
          <a:lstStyle>
            <a:lvl1pPr marL="0" indent="0">
              <a:buNone/>
              <a:defRPr sz="1266"/>
            </a:lvl1pPr>
            <a:lvl2pPr marL="361782" indent="0">
              <a:buNone/>
              <a:defRPr sz="1108"/>
            </a:lvl2pPr>
            <a:lvl3pPr marL="723565" indent="0">
              <a:buNone/>
              <a:defRPr sz="950"/>
            </a:lvl3pPr>
            <a:lvl4pPr marL="1085347" indent="0">
              <a:buNone/>
              <a:defRPr sz="791"/>
            </a:lvl4pPr>
            <a:lvl5pPr marL="1447129" indent="0">
              <a:buNone/>
              <a:defRPr sz="791"/>
            </a:lvl5pPr>
            <a:lvl6pPr marL="1808912" indent="0">
              <a:buNone/>
              <a:defRPr sz="791"/>
            </a:lvl6pPr>
            <a:lvl7pPr marL="2170694" indent="0">
              <a:buNone/>
              <a:defRPr sz="791"/>
            </a:lvl7pPr>
            <a:lvl8pPr marL="2532477" indent="0">
              <a:buNone/>
              <a:defRPr sz="791"/>
            </a:lvl8pPr>
            <a:lvl9pPr marL="2894259" indent="0">
              <a:buNone/>
              <a:defRPr sz="79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6312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7463" y="569242"/>
            <a:ext cx="6240899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7463" y="2846200"/>
            <a:ext cx="6240899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7463" y="9909729"/>
            <a:ext cx="162806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19F87-D8EA-40DD-B543-DE9FA82A91B6}" type="datetimeFigureOut">
              <a:rPr lang="zh-CN" altLang="en-US" smtClean="0"/>
              <a:t>2025/3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96867" y="9909729"/>
            <a:ext cx="244209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10301" y="9909729"/>
            <a:ext cx="162806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18F0AF-4C8D-4570-AA3A-9FC1CFD248B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7841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23565" rtl="0" eaLnBrk="1" latinLnBrk="0" hangingPunct="1">
        <a:lnSpc>
          <a:spcPct val="90000"/>
        </a:lnSpc>
        <a:spcBef>
          <a:spcPct val="0"/>
        </a:spcBef>
        <a:buNone/>
        <a:defRPr sz="34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0891" indent="-180891" algn="l" defTabSz="723565" rtl="0" eaLnBrk="1" latinLnBrk="0" hangingPunct="1">
        <a:lnSpc>
          <a:spcPct val="90000"/>
        </a:lnSpc>
        <a:spcBef>
          <a:spcPts val="791"/>
        </a:spcBef>
        <a:buFont typeface="Arial" panose="020B0604020202020204" pitchFamily="34" charset="0"/>
        <a:buChar char="•"/>
        <a:defRPr sz="2216" kern="1200">
          <a:solidFill>
            <a:schemeClr val="tx1"/>
          </a:solidFill>
          <a:latin typeface="+mn-lt"/>
          <a:ea typeface="+mn-ea"/>
          <a:cs typeface="+mn-cs"/>
        </a:defRPr>
      </a:lvl1pPr>
      <a:lvl2pPr marL="542674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899" kern="1200">
          <a:solidFill>
            <a:schemeClr val="tx1"/>
          </a:solidFill>
          <a:latin typeface="+mn-lt"/>
          <a:ea typeface="+mn-ea"/>
          <a:cs typeface="+mn-cs"/>
        </a:defRPr>
      </a:lvl2pPr>
      <a:lvl3pPr marL="904456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583" kern="1200">
          <a:solidFill>
            <a:schemeClr val="tx1"/>
          </a:solidFill>
          <a:latin typeface="+mn-lt"/>
          <a:ea typeface="+mn-ea"/>
          <a:cs typeface="+mn-cs"/>
        </a:defRPr>
      </a:lvl3pPr>
      <a:lvl4pPr marL="1266238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4pPr>
      <a:lvl5pPr marL="1628021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5pPr>
      <a:lvl6pPr marL="1989803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6pPr>
      <a:lvl7pPr marL="2351585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7pPr>
      <a:lvl8pPr marL="2713368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8pPr>
      <a:lvl9pPr marL="3075150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1pPr>
      <a:lvl2pPr marL="361782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2pPr>
      <a:lvl3pPr marL="723565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3pPr>
      <a:lvl4pPr marL="1085347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4pPr>
      <a:lvl5pPr marL="1447129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5pPr>
      <a:lvl6pPr marL="1808912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6pPr>
      <a:lvl7pPr marL="2170694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7pPr>
      <a:lvl8pPr marL="2532477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8pPr>
      <a:lvl9pPr marL="2894259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F705CE-44BB-4CCA-9220-8000710954C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zh-CN" sz="4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upplemental Figures</a:t>
            </a:r>
            <a:endParaRPr lang="zh-CN" altLang="en-US" sz="4400" dirty="0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ECA38A2-D053-4BBC-B348-EABE4C9F26E2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175019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5666" y="1538747"/>
            <a:ext cx="6488931" cy="68400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353957" y="2563959"/>
            <a:ext cx="6450639" cy="11671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| Genotyping analysis of ZY50, S201 and Fertile (F)/sterile (S) pools from F2 </a:t>
            </a:r>
            <a:r>
              <a:rPr lang="en-US" altLang="zh-CN" sz="1200" kern="0" dirty="0">
                <a:latin typeface="Times New Roman" panose="02020603050405020304" pitchFamily="18" charset="0"/>
                <a:ea typeface="宋体" panose="02010600030101010101" pitchFamily="2" charset="-122"/>
              </a:rPr>
              <a:t>generation using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igh-density chip detection. Blue </a:t>
            </a:r>
            <a:r>
              <a:rPr lang="en-US" altLang="zh-CN" sz="1200" kern="0" dirty="0">
                <a:latin typeface="Times New Roman" panose="02020603050405020304" pitchFamily="18" charset="0"/>
                <a:ea typeface="宋体" panose="02010600030101010101" pitchFamily="2" charset="-122"/>
              </a:rPr>
              <a:t>indicates the heterozygous genotyp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 gray represents homozygous genotype consistent with  S201, and red represents homozygous genotype consistent with the parental ZY 50.</a:t>
            </a:r>
          </a:p>
        </p:txBody>
      </p:sp>
    </p:spTree>
    <p:extLst>
      <p:ext uri="{BB962C8B-B14F-4D97-AF65-F5344CB8AC3E}">
        <p14:creationId xmlns:p14="http://schemas.microsoft.com/office/powerpoint/2010/main" val="27409650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矩形 9"/>
          <p:cNvSpPr/>
          <p:nvPr/>
        </p:nvSpPr>
        <p:spPr>
          <a:xfrm>
            <a:off x="750288" y="573047"/>
            <a:ext cx="5685211" cy="55394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526" cap="all" dirty="0">
                <a:latin typeface="Arial" pitchFamily="34" charset="0"/>
                <a:cs typeface="Arial" pitchFamily="34" charset="0"/>
              </a:rPr>
              <a:t>Attgtaggatccaaaaggagtgttagaagatgatatattacctaatggaacaaaagtaaaagcaggaggaatggtaacatatgttccttactcaatgggtcgtatggagtacaactgg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cap="all" dirty="0">
                <a:latin typeface="Arial" pitchFamily="34" charset="0"/>
                <a:cs typeface="Arial" pitchFamily="34" charset="0"/>
              </a:rPr>
              <a:t>Attgtaggatccaaaaggagtgttagaagatgatatattacctaatggaacaaaagtaaaagcaggaggaatggtaacatatgttccttactcaatgggtcgtatggagtacaactgg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cap="all" dirty="0">
                <a:latin typeface="Arial" pitchFamily="34" charset="0"/>
                <a:cs typeface="Arial" pitchFamily="34" charset="0"/>
              </a:rPr>
              <a:t>Attgtaggatccaaaaggagtgttagaagatgatatattacctaatggaacaaaagtaaaagcaggaggaatggtaacatatgttccttactcaatgggtcgtatggagtacaactgg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CACTACAAAAAAACTGTTGTTTAGCATCATTTATTTTGTATTTTTGCATTAGTTATAAATGATGTAAAATAATTTTACATCATTTATATAAATGACTCTGAAAGTGGTGATGCAAATAATTC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CACTACAAAAAAACTGTTGTTTAGCATCATTTATTTTGTATTTTTGCATTAGTTATAAATGATGTAAAATAATTTTACATCATTTATATAAATGACTCTGAAAGTGGTGATGCAAATAATTC 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-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ACATCATTTTGTTAGTAAATGATGTAAAAATGCTAAATATTTACATCAGCTATTATAAATGATGTAAAATATATATCAATTACAATAACTGATATTAATATTTATATCATTTATTAAAATGAT 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ACATCATTTTGTTAGTAAATGATGTAAAAATGCTAAATATTTACATCAGCTATTATAAATGATGTAAAATATATATCAATTACAATAACTGATATTAATATTTATATCATTTATTAAAATGAT 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-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GTTAATATTAGAATCAATCAATTAATTTATTTTAATAATTAATTATATCACTTTTGGTAATTGAATAACTAAATTATTATCATGTTGATTTTTTAATCTTATTAATATTCATACAAAATTAATAT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GTTAATATTAGAATCAATCAATTAATTTATTTTAATAATTAATTATATCACTTTTGGTAATTGAATAACTAAATTATTATCATGTTGATTTTTTAATCTTATTAATATTCATACAAAATTAATAT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-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TAAATTGATAACAGTAAATAAATAAATTAAATACTTTTATTAATTGTTAATTATTTCTTATTGTTCTTTTCATTGAAGTTACAATTAAAAATAAGAAAATTACAAAAACAAGAAAACAAAAGA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TAAATTGATAACAGTAAATAAATAAATTAAATACTTTTATTAATTGTTAATTATTTCTTATTGTTCTTTTCATTGAAGTTACAATTAAAAATAAGAAAATTACAAAAACAAGAAAACAAAAGA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-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ATACAATTAAAAAAAACAGATAAACATAGTTCGCCGTAAGAGTTCTTCGATCAAGTTTCTTCTTCTTCCAATTCTCTGTATCTTTTGCTGTTGGTTGTAGGGTTTTAAGCTAATAGTTTCT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 ATACAATTAAAAAAAACAGATAAACATAGTTCGCCGTAAGAGTTCTTCGATCAAGTTTCTTCTTCTTCCAATTCTCTGTATCTTTTGCTGTTGGTTGTAGGGTTTTAAGCTAATAGTTTCT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</a:t>
            </a:r>
            <a:r>
              <a:rPr lang="en-US" altLang="zh-CN" sz="526" dirty="0">
                <a:latin typeface="Arial" pitchFamily="34" charset="0"/>
                <a:cs typeface="Arial" pitchFamily="34" charset="0"/>
              </a:rPr>
              <a:t>TCTACAAATAAAACCATAATCATCATCACTCATATAAGAAAATACCGATTCATAGACAAAAACAATATAAAGAAAAGTTTGCATCAGATTGTCACTATTGACTAACCTTAACCAATGGTT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 TCTACAAATAAAACCATAATCATCATCACTCATATAAGAAAATACCGATTCATAGACAAAAACAATATAAAGAAAAGTTTGCATCAGATTGTCACTATTGACTAACCTTAACCAATGGTT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-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CCTGAGGTAAACAATAATAGACTTCACGAAGGTTCCAAGAATATTATTTCAGATCTGCAGATTCAACCCTCTTAAACTGTGTTAAGGAATTGTGTGTGGAAGAAAAGACTTTGCAAAAA 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CCTGAGGTAAACAATAATAGACTTCACGAAGGTTCCAAGAATATTATTTCAGATCTGCAGATTCAACCCTCTTAAACTGTGTTAAGGAATTGTGTGTGGAAGAAAAGACTTTGCAAAAA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-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AATGTAAAGGATCGTTGCTTTTATTCAGTTGATTTCTTATTAGAAAGAAACGTGAACTAGTGGTGAGATAAAATAGGAGATATTGCTATATTTTTGGTAACAAACATATAGATTTTTAATG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AATGTAAAGGATCGTTGCTTTTATTCAGTTGATTTCTTATTAGAAAGAAACGTGAACTAGTGGTGAGATAAAATAGGAGATATTGCTATATTTTTGGTAACAAACATATAGATTTTTAATG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</a:t>
            </a:r>
            <a:r>
              <a:rPr lang="en-US" altLang="zh-CN" sz="526" dirty="0">
                <a:latin typeface="Arial" pitchFamily="34" charset="0"/>
                <a:cs typeface="Arial" pitchFamily="34" charset="0"/>
              </a:rPr>
              <a:t>GTTTACAATTTTCTTTACAAAACAAATTAACGCAGTACAGATATAAGATTAACTATTAACATTTATTAATTAGGTCCAAAATTTAAAAATATTAGTTGTAAAAAAAATAGAATAACTTCTTT  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GTTTACAATTTTCTTTACAAAACAAATTAACGCAGTACAGATATAAGATTAACTATTAACATTTATTAATTAGGTCCAAAATTTAAAAATATTAGTTGTAAAAAAAATAGAATAACTTCTTT  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-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CTTTTAATTAAATATGTATTCTAGTGAGTATAAAAATGTTTTTTTTTAAATATAGATTTTCAGATTCTTTATTTAGTCAATATATATGTTATATTTTTAATATTCAAAATATCAATTAATGTAG 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 CTTTTAATTAAATATGTATTCTAGTGAGTATAAAAATGTTTTTTTTTAAATATAGATTTTCAGATTCTTTATTTAGTCAATATATATGTTATATTTTTAATATTCAAAATATCAATTAATGTAG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-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CTTACTTATTAAATCAATTCAAAATTATTTATCAAAGCATAAAAACTCGTTTATAAGCAGAAATGATCTACGTACATATTAGTAACTAATGAAAATTATGTTAGTATCATTTTTATCATTGA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  CTTACTTATTAAATCAATTCAAAATTATTTATCAAAGCATAAAAACTCGTTTATAAGCAGAAATGATCTACGTACATATTAGTAACTAATGAAAATTATGTTAGTATCATTTTTATCATTGA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-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TGTCAAATTTGCAACATTTATTAAAATGATGTTACTTTTGAATCATTTTAATAAGTGATGTTAATACAAATTAATAAATGTATCGATCATTTAATTGATGTAAACTCATATTTTCTATCATTT 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TGTCAAATTTGCAACATTTATTAAAATGATGTTACTTTTGAATCATTTTAATAAGTGATGTTAATACAAATTAATAAATGTATCGATCATTTAATTGATGTAAACTCATATTTTCTATCATTT 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-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TTCAAAAAGTGATGTAAACTAATAAAGATTTGCATCAATTTCAYTCAATCGATGCCAAACAAGTTAATAACCGCATCGTTTGTTATGACTGATGTTAAAACAGATATTTTGTATCATTTCC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TTCAAAAAGTGATGTAAACTAATAAAGATTTGCATCAATTTCAYTCAATCGATGCCAAACAAGTTAATAACCGCATCGTTTGTTATGACTGATGTTAAAACAGATATTTTGTATCATTTCC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--------------------------------------------------------------------------------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TAACAAGTAATTCTAAATAGTATCATTTATTTTTGTGATTCTATTTAAGTGATGTAATATGATCCTTTTTTTGCAGTGTGG</a:t>
            </a:r>
            <a:r>
              <a:rPr lang="en-US" altLang="zh-CN" sz="526" cap="all" dirty="0">
                <a:latin typeface="Arial" pitchFamily="34" charset="0"/>
                <a:cs typeface="Arial" pitchFamily="34" charset="0"/>
              </a:rPr>
              <a:t>ggatcagatgcagcaatgtttaaaccagaaagatggctta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TAACAAGTAATTCTAAATAGTATCATTTATTTTTGTGATTCTATTTAAGTGATGTAATATGATCCTTTTTTTGCAGTGTGG</a:t>
            </a:r>
            <a:r>
              <a:rPr lang="en-US" altLang="zh-CN" sz="526" cap="all" dirty="0">
                <a:latin typeface="Arial" pitchFamily="34" charset="0"/>
                <a:cs typeface="Arial" pitchFamily="34" charset="0"/>
              </a:rPr>
              <a:t>ggatcagatgcagcaatgtttaaaccagaaagatggctta </a:t>
            </a:r>
          </a:p>
          <a:p>
            <a:pPr algn="just">
              <a:lnSpc>
                <a:spcPct val="150000"/>
              </a:lnSpc>
            </a:pPr>
            <a:r>
              <a:rPr lang="en-US" altLang="zh-CN" sz="526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------------------------------------------------------------------------------------------------------------------------------------------------------------</a:t>
            </a:r>
            <a:r>
              <a:rPr lang="en-US" altLang="zh-CN" sz="526" cap="all" dirty="0" err="1">
                <a:latin typeface="Arial" pitchFamily="34" charset="0"/>
                <a:cs typeface="Arial" pitchFamily="34" charset="0"/>
              </a:rPr>
              <a:t>ggatcagatgcagcaatgtttaaaccagaaagatggcTTA</a:t>
            </a:r>
            <a:endParaRPr lang="en-US" altLang="zh-CN" sz="526" cap="all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50509" y="582097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矩形 26"/>
          <p:cNvSpPr/>
          <p:nvPr/>
        </p:nvSpPr>
        <p:spPr>
          <a:xfrm>
            <a:off x="6261772" y="560695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cap="all" dirty="0">
                <a:latin typeface="Arial" pitchFamily="34" charset="0"/>
                <a:cs typeface="Arial" pitchFamily="34" charset="0"/>
              </a:rPr>
              <a:t>1811</a:t>
            </a:r>
          </a:p>
        </p:txBody>
      </p:sp>
      <p:sp>
        <p:nvSpPr>
          <p:cNvPr id="28" name="矩形 27"/>
          <p:cNvSpPr/>
          <p:nvPr/>
        </p:nvSpPr>
        <p:spPr>
          <a:xfrm>
            <a:off x="6262846" y="685116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cap="all" dirty="0">
                <a:latin typeface="Arial" pitchFamily="34" charset="0"/>
                <a:cs typeface="Arial" pitchFamily="34" charset="0"/>
              </a:rPr>
              <a:t>1814</a:t>
            </a:r>
          </a:p>
        </p:txBody>
      </p:sp>
      <p:sp>
        <p:nvSpPr>
          <p:cNvPr id="29" name="矩形 28"/>
          <p:cNvSpPr/>
          <p:nvPr/>
        </p:nvSpPr>
        <p:spPr>
          <a:xfrm>
            <a:off x="6263282" y="927761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1933</a:t>
            </a:r>
          </a:p>
        </p:txBody>
      </p:sp>
      <p:sp>
        <p:nvSpPr>
          <p:cNvPr id="30" name="矩形 29"/>
          <p:cNvSpPr/>
          <p:nvPr/>
        </p:nvSpPr>
        <p:spPr>
          <a:xfrm>
            <a:off x="6270762" y="1418127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059</a:t>
            </a:r>
          </a:p>
        </p:txBody>
      </p:sp>
      <p:sp>
        <p:nvSpPr>
          <p:cNvPr id="32" name="矩形 31"/>
          <p:cNvSpPr/>
          <p:nvPr/>
        </p:nvSpPr>
        <p:spPr>
          <a:xfrm>
            <a:off x="6264324" y="1781732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184</a:t>
            </a:r>
          </a:p>
        </p:txBody>
      </p:sp>
      <p:sp>
        <p:nvSpPr>
          <p:cNvPr id="33" name="矩形 32"/>
          <p:cNvSpPr/>
          <p:nvPr/>
        </p:nvSpPr>
        <p:spPr>
          <a:xfrm>
            <a:off x="6271293" y="2142120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307</a:t>
            </a:r>
          </a:p>
        </p:txBody>
      </p:sp>
      <p:sp>
        <p:nvSpPr>
          <p:cNvPr id="34" name="矩形 33"/>
          <p:cNvSpPr/>
          <p:nvPr/>
        </p:nvSpPr>
        <p:spPr>
          <a:xfrm>
            <a:off x="6268529" y="2494286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428</a:t>
            </a:r>
          </a:p>
        </p:txBody>
      </p:sp>
      <p:sp>
        <p:nvSpPr>
          <p:cNvPr id="35" name="矩形 34"/>
          <p:cNvSpPr/>
          <p:nvPr/>
        </p:nvSpPr>
        <p:spPr>
          <a:xfrm>
            <a:off x="6270066" y="2853243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548</a:t>
            </a:r>
          </a:p>
        </p:txBody>
      </p:sp>
      <p:sp>
        <p:nvSpPr>
          <p:cNvPr id="36" name="矩形 35"/>
          <p:cNvSpPr/>
          <p:nvPr/>
        </p:nvSpPr>
        <p:spPr>
          <a:xfrm>
            <a:off x="6269688" y="3224353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667</a:t>
            </a:r>
          </a:p>
        </p:txBody>
      </p:sp>
      <p:sp>
        <p:nvSpPr>
          <p:cNvPr id="37" name="矩形 36"/>
          <p:cNvSpPr/>
          <p:nvPr/>
        </p:nvSpPr>
        <p:spPr>
          <a:xfrm>
            <a:off x="6270219" y="3576161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788</a:t>
            </a:r>
          </a:p>
        </p:txBody>
      </p:sp>
      <p:sp>
        <p:nvSpPr>
          <p:cNvPr id="38" name="矩形 37"/>
          <p:cNvSpPr/>
          <p:nvPr/>
        </p:nvSpPr>
        <p:spPr>
          <a:xfrm>
            <a:off x="6269184" y="3932786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910</a:t>
            </a:r>
          </a:p>
        </p:txBody>
      </p:sp>
      <p:sp>
        <p:nvSpPr>
          <p:cNvPr id="39" name="矩形 38"/>
          <p:cNvSpPr/>
          <p:nvPr/>
        </p:nvSpPr>
        <p:spPr>
          <a:xfrm>
            <a:off x="6269757" y="4300319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3034</a:t>
            </a:r>
          </a:p>
        </p:txBody>
      </p:sp>
      <p:sp>
        <p:nvSpPr>
          <p:cNvPr id="40" name="矩形 39"/>
          <p:cNvSpPr/>
          <p:nvPr/>
        </p:nvSpPr>
        <p:spPr>
          <a:xfrm>
            <a:off x="6270072" y="4541104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3153</a:t>
            </a:r>
          </a:p>
        </p:txBody>
      </p:sp>
      <p:sp>
        <p:nvSpPr>
          <p:cNvPr id="41" name="矩形 40"/>
          <p:cNvSpPr/>
          <p:nvPr/>
        </p:nvSpPr>
        <p:spPr>
          <a:xfrm>
            <a:off x="6271824" y="5020925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3279</a:t>
            </a:r>
          </a:p>
        </p:txBody>
      </p:sp>
      <p:sp>
        <p:nvSpPr>
          <p:cNvPr id="42" name="矩形 41"/>
          <p:cNvSpPr/>
          <p:nvPr/>
        </p:nvSpPr>
        <p:spPr>
          <a:xfrm>
            <a:off x="6266940" y="5256562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3397</a:t>
            </a:r>
          </a:p>
        </p:txBody>
      </p:sp>
      <p:sp>
        <p:nvSpPr>
          <p:cNvPr id="43" name="矩形 42"/>
          <p:cNvSpPr/>
          <p:nvPr/>
        </p:nvSpPr>
        <p:spPr>
          <a:xfrm>
            <a:off x="6269682" y="5732585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3521</a:t>
            </a:r>
          </a:p>
        </p:txBody>
      </p:sp>
      <p:sp>
        <p:nvSpPr>
          <p:cNvPr id="44" name="矩形 43"/>
          <p:cNvSpPr/>
          <p:nvPr/>
        </p:nvSpPr>
        <p:spPr>
          <a:xfrm>
            <a:off x="6263045" y="5860765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1852</a:t>
            </a:r>
          </a:p>
        </p:txBody>
      </p:sp>
      <p:sp>
        <p:nvSpPr>
          <p:cNvPr id="46" name="矩形 45"/>
          <p:cNvSpPr/>
          <p:nvPr/>
        </p:nvSpPr>
        <p:spPr>
          <a:xfrm>
            <a:off x="6262858" y="813828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cap="all" dirty="0">
                <a:latin typeface="Arial" pitchFamily="34" charset="0"/>
                <a:cs typeface="Arial" pitchFamily="34" charset="0"/>
              </a:rPr>
              <a:t>1812</a:t>
            </a:r>
          </a:p>
        </p:txBody>
      </p:sp>
      <p:sp>
        <p:nvSpPr>
          <p:cNvPr id="47" name="矩形 46"/>
          <p:cNvSpPr/>
          <p:nvPr/>
        </p:nvSpPr>
        <p:spPr>
          <a:xfrm>
            <a:off x="6263293" y="1052183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1937</a:t>
            </a:r>
          </a:p>
        </p:txBody>
      </p:sp>
      <p:sp>
        <p:nvSpPr>
          <p:cNvPr id="48" name="矩形 47"/>
          <p:cNvSpPr/>
          <p:nvPr/>
        </p:nvSpPr>
        <p:spPr>
          <a:xfrm>
            <a:off x="6266483" y="1293729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056</a:t>
            </a:r>
          </a:p>
        </p:txBody>
      </p:sp>
      <p:sp>
        <p:nvSpPr>
          <p:cNvPr id="49" name="矩形 48"/>
          <p:cNvSpPr/>
          <p:nvPr/>
        </p:nvSpPr>
        <p:spPr>
          <a:xfrm>
            <a:off x="6264336" y="1648753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181</a:t>
            </a:r>
          </a:p>
        </p:txBody>
      </p:sp>
      <p:sp>
        <p:nvSpPr>
          <p:cNvPr id="50" name="矩形 49"/>
          <p:cNvSpPr/>
          <p:nvPr/>
        </p:nvSpPr>
        <p:spPr>
          <a:xfrm>
            <a:off x="6267015" y="2017722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304</a:t>
            </a:r>
          </a:p>
        </p:txBody>
      </p:sp>
      <p:sp>
        <p:nvSpPr>
          <p:cNvPr id="51" name="矩形 50"/>
          <p:cNvSpPr/>
          <p:nvPr/>
        </p:nvSpPr>
        <p:spPr>
          <a:xfrm>
            <a:off x="6266924" y="2373452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425</a:t>
            </a:r>
          </a:p>
        </p:txBody>
      </p:sp>
      <p:sp>
        <p:nvSpPr>
          <p:cNvPr id="52" name="矩形 51"/>
          <p:cNvSpPr/>
          <p:nvPr/>
        </p:nvSpPr>
        <p:spPr>
          <a:xfrm>
            <a:off x="6267870" y="2739714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545</a:t>
            </a:r>
          </a:p>
        </p:txBody>
      </p:sp>
      <p:sp>
        <p:nvSpPr>
          <p:cNvPr id="53" name="矩形 52"/>
          <p:cNvSpPr/>
          <p:nvPr/>
        </p:nvSpPr>
        <p:spPr>
          <a:xfrm>
            <a:off x="6269066" y="3090064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664</a:t>
            </a:r>
          </a:p>
        </p:txBody>
      </p:sp>
      <p:sp>
        <p:nvSpPr>
          <p:cNvPr id="54" name="矩形 53"/>
          <p:cNvSpPr/>
          <p:nvPr/>
        </p:nvSpPr>
        <p:spPr>
          <a:xfrm>
            <a:off x="6269007" y="3458343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785</a:t>
            </a:r>
          </a:p>
        </p:txBody>
      </p:sp>
      <p:sp>
        <p:nvSpPr>
          <p:cNvPr id="55" name="矩形 54"/>
          <p:cNvSpPr/>
          <p:nvPr/>
        </p:nvSpPr>
        <p:spPr>
          <a:xfrm>
            <a:off x="6268529" y="3824260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2907</a:t>
            </a:r>
          </a:p>
        </p:txBody>
      </p:sp>
      <p:sp>
        <p:nvSpPr>
          <p:cNvPr id="56" name="矩形 55"/>
          <p:cNvSpPr/>
          <p:nvPr/>
        </p:nvSpPr>
        <p:spPr>
          <a:xfrm>
            <a:off x="6264894" y="4169631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3031</a:t>
            </a:r>
          </a:p>
        </p:txBody>
      </p:sp>
      <p:sp>
        <p:nvSpPr>
          <p:cNvPr id="57" name="矩形 56"/>
          <p:cNvSpPr/>
          <p:nvPr/>
        </p:nvSpPr>
        <p:spPr>
          <a:xfrm>
            <a:off x="6271085" y="4658886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3156</a:t>
            </a:r>
          </a:p>
        </p:txBody>
      </p:sp>
      <p:sp>
        <p:nvSpPr>
          <p:cNvPr id="58" name="矩形 57"/>
          <p:cNvSpPr/>
          <p:nvPr/>
        </p:nvSpPr>
        <p:spPr>
          <a:xfrm>
            <a:off x="6264585" y="4898813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3276</a:t>
            </a:r>
          </a:p>
        </p:txBody>
      </p:sp>
      <p:sp>
        <p:nvSpPr>
          <p:cNvPr id="59" name="矩形 58"/>
          <p:cNvSpPr/>
          <p:nvPr/>
        </p:nvSpPr>
        <p:spPr>
          <a:xfrm>
            <a:off x="6268620" y="5385078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3400</a:t>
            </a:r>
          </a:p>
        </p:txBody>
      </p:sp>
      <p:sp>
        <p:nvSpPr>
          <p:cNvPr id="60" name="矩形 59"/>
          <p:cNvSpPr/>
          <p:nvPr/>
        </p:nvSpPr>
        <p:spPr>
          <a:xfrm>
            <a:off x="6267393" y="5623879"/>
            <a:ext cx="332142" cy="19877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dirty="0">
                <a:latin typeface="Arial" pitchFamily="34" charset="0"/>
                <a:cs typeface="Arial" pitchFamily="34" charset="0"/>
              </a:rPr>
              <a:t>3518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251347" y="938017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49950" y="1288936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50799" y="1654178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251636" y="2015100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52474" y="2391025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53311" y="2741944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54149" y="3097864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249985" y="3458785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50822" y="3819707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251660" y="4190631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52497" y="4541550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53335" y="4902471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54173" y="5258391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50009" y="5619313"/>
            <a:ext cx="617477" cy="4415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S20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Y50:</a:t>
            </a:r>
          </a:p>
          <a:p>
            <a:pPr>
              <a:lnSpc>
                <a:spcPct val="150000"/>
              </a:lnSpc>
            </a:pPr>
            <a:r>
              <a:rPr lang="en-US" altLang="zh-CN" sz="526" b="1" i="1" dirty="0">
                <a:latin typeface="Arial" pitchFamily="34" charset="0"/>
                <a:cs typeface="Arial" pitchFamily="34" charset="0"/>
              </a:rPr>
              <a:t>BnMS2-Zs11:</a:t>
            </a:r>
            <a:endParaRPr lang="en-US" altLang="zh-CN" sz="526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文本框 43"/>
          <p:cNvSpPr txBox="1"/>
          <p:nvPr/>
        </p:nvSpPr>
        <p:spPr>
          <a:xfrm>
            <a:off x="249949" y="6129782"/>
            <a:ext cx="6609930" cy="856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149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| Alignment of partial nucleotide sequence of the </a:t>
            </a:r>
            <a:r>
              <a:rPr lang="en-US" altLang="zh-CN" sz="1149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2</a:t>
            </a:r>
            <a:r>
              <a:rPr lang="en-US" altLang="zh-CN" sz="114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from ZS11, ZY50 and S201.  Sequence comparison shows that both ZY50 and S201 contain a 1667 bp fragment insertion at the 3’ end of 5’-TGGAGTACAACTGG-3’ in  the 5th exon of </a:t>
            </a:r>
            <a:r>
              <a:rPr lang="en-US" altLang="zh-CN" sz="1149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MS2</a:t>
            </a:r>
            <a:r>
              <a:rPr lang="en-US" altLang="zh-CN" sz="1149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. </a:t>
            </a:r>
          </a:p>
        </p:txBody>
      </p:sp>
    </p:spTree>
    <p:extLst>
      <p:ext uri="{BB962C8B-B14F-4D97-AF65-F5344CB8AC3E}">
        <p14:creationId xmlns:p14="http://schemas.microsoft.com/office/powerpoint/2010/main" val="33886088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165560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280</Words>
  <Application>Microsoft Office PowerPoint</Application>
  <PresentationFormat>自定义</PresentationFormat>
  <Paragraphs>12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主题​​</vt:lpstr>
      <vt:lpstr>Supplemental Figures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Administrator</dc:creator>
  <cp:lastModifiedBy>Administrator</cp:lastModifiedBy>
  <cp:revision>5</cp:revision>
  <dcterms:created xsi:type="dcterms:W3CDTF">2025-03-06T06:42:12Z</dcterms:created>
  <dcterms:modified xsi:type="dcterms:W3CDTF">2025-03-19T04:47:07Z</dcterms:modified>
</cp:coreProperties>
</file>